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56" autoAdjust="0"/>
  </p:normalViewPr>
  <p:slideViewPr>
    <p:cSldViewPr>
      <p:cViewPr varScale="1">
        <p:scale>
          <a:sx n="107" d="100"/>
          <a:sy n="107" d="100"/>
        </p:scale>
        <p:origin x="-114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C0CBD9-AC09-49EA-9CBD-FA01C4092C79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EDFF66-32FF-4C79-8D19-59A2813E82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936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4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3033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81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6899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764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3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69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486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011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381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1070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05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23528" y="188640"/>
            <a:ext cx="7799038" cy="5904658"/>
            <a:chOff x="372140" y="260647"/>
            <a:chExt cx="7799038" cy="5904658"/>
          </a:xfrm>
        </p:grpSpPr>
        <p:pic>
          <p:nvPicPr>
            <p:cNvPr id="1026" name="Picture 2" descr="F:\Article carte F2\Photos F2 170713\Normal microarray Sarah\F2_101_2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4" r="11481" b="978"/>
            <a:stretch/>
          </p:blipFill>
          <p:spPr bwMode="auto">
            <a:xfrm>
              <a:off x="372140" y="260648"/>
              <a:ext cx="3856611" cy="59046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 descr="F:\Article carte F2\Photos F2 180713\DSC03402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18" t="17794" r="31632" b="8220"/>
            <a:stretch/>
          </p:blipFill>
          <p:spPr bwMode="auto">
            <a:xfrm>
              <a:off x="6561978" y="260647"/>
              <a:ext cx="1608701" cy="22015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" name="Groupe 3"/>
            <p:cNvGrpSpPr/>
            <p:nvPr/>
          </p:nvGrpSpPr>
          <p:grpSpPr>
            <a:xfrm>
              <a:off x="4248000" y="260648"/>
              <a:ext cx="2293200" cy="5904657"/>
              <a:chOff x="4269284" y="260648"/>
              <a:chExt cx="2293200" cy="5904657"/>
            </a:xfrm>
          </p:grpSpPr>
          <p:pic>
            <p:nvPicPr>
              <p:cNvPr id="1029" name="Picture 5" descr="F:\Article carte F2\Photos F2 180713\DSC03398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78" t="20968" r="27416" b="14825"/>
              <a:stretch/>
            </p:blipFill>
            <p:spPr bwMode="auto">
              <a:xfrm>
                <a:off x="4269284" y="2404801"/>
                <a:ext cx="2293200" cy="376050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 descr="F:\Article carte F2\Photos F2 170713\Dwarf microarray sarah\F2_094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458" t="32615" r="7865" b="16225"/>
              <a:stretch/>
            </p:blipFill>
            <p:spPr bwMode="auto">
              <a:xfrm>
                <a:off x="4269285" y="260648"/>
                <a:ext cx="2292693" cy="212271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1" name="Picture 6" descr="F:\Article carte F2\Photos F2 180713\DSC03410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61978" y="3707128"/>
              <a:ext cx="1608701" cy="12065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7" descr="F:\Article carte F2\Photos F2 180713\DSC03409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61978" y="2481389"/>
              <a:ext cx="1608701" cy="12065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F:\Article carte F2\Photos F2 180713\DSC03404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63" t="38580" r="28773" b="11215"/>
            <a:stretch/>
          </p:blipFill>
          <p:spPr bwMode="auto">
            <a:xfrm>
              <a:off x="6561978" y="4932867"/>
              <a:ext cx="1609200" cy="12324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395536" y="260648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260572" y="260648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4260572" y="2420888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564828" y="260648"/>
              <a:ext cx="432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564828" y="2492896"/>
              <a:ext cx="432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564828" y="3717032"/>
              <a:ext cx="360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564828" y="4930135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251520" y="6279703"/>
            <a:ext cx="9145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: Fig. 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s of CS x RGM_F2 population growing in a greenhouse.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s with normal phenotyp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s with dwarf phenotypes showing curled-leaf phenotype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8363429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0</TotalTime>
  <Words>42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ine</dc:creator>
  <cp:lastModifiedBy>Sabine</cp:lastModifiedBy>
  <cp:revision>82</cp:revision>
  <dcterms:created xsi:type="dcterms:W3CDTF">2016-03-30T14:19:26Z</dcterms:created>
  <dcterms:modified xsi:type="dcterms:W3CDTF">2020-01-16T09:23:34Z</dcterms:modified>
</cp:coreProperties>
</file>